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5AD45-F921-40EE-8187-37B56E8016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D71E8-E41E-485E-A250-8E5B5B1014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3C5D2-8227-4880-913D-741C8D6E91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C970E-600E-4EE5-B12E-8D320A2402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3866A-2488-4A5B-A7E0-6FE60D9442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A1698-6285-4C9A-A847-4426A41E8E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64601-57D1-469D-A8AC-1DCC8154ED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E5662-76C2-4D0B-A819-02CC8F73AF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18CFB-0EE8-4C0F-9D92-7B9B6A78A6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9A294-AC61-4EC3-8FEA-AE8111D3B2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359BD-320B-4335-9E3A-2038FE4765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A215C-5BD9-485E-814E-2CDADE6C86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E905E2-01E0-4392-BFFB-01B665A22E2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ct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58840" y="-230040"/>
            <a:ext cx="7315200" cy="9321480"/>
            <a:chOff x="1158840" y="-230040"/>
            <a:chExt cx="7315200" cy="93214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158840" y="-230040"/>
              <a:ext cx="7315200" cy="9321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218960" y="199800"/>
              <a:ext cx="5999400" cy="1963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"/>
          <p:cNvSpPr/>
          <p:nvPr/>
        </p:nvSpPr>
        <p:spPr>
          <a:xfrm>
            <a:off x="550080" y="328680"/>
            <a:ext cx="170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3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4126320" y="189432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6404400" y="193968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lo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1530720" y="193716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ruj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1711440" y="1914840"/>
            <a:ext cx="49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zh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2137320" y="193860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ruj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3949560" y="1914840"/>
            <a:ext cx="49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zh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5342400" y="190368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5692320" y="1834920"/>
            <a:ext cx="660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elepen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5922720" y="1873440"/>
            <a:ext cx="59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lbasa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6534000" y="1859040"/>
            <a:ext cx="60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hkode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5564520" y="1911240"/>
            <a:ext cx="51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urb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773280" y="-372960"/>
            <a:ext cx="8088120" cy="9144000"/>
            <a:chOff x="773280" y="-372960"/>
            <a:chExt cx="8088120" cy="9144000"/>
          </a:xfrm>
        </p:grpSpPr>
        <p:grpSp>
          <p:nvGrpSpPr>
            <p:cNvPr id="57" name=""/>
            <p:cNvGrpSpPr/>
            <p:nvPr/>
          </p:nvGrpSpPr>
          <p:grpSpPr>
            <a:xfrm>
              <a:off x="995400" y="-372960"/>
              <a:ext cx="7866000" cy="9144000"/>
              <a:chOff x="995400" y="-372960"/>
              <a:chExt cx="7866000" cy="9144000"/>
            </a:xfrm>
          </p:grpSpPr>
          <p:pic>
            <p:nvPicPr>
              <p:cNvPr id="58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995400" y="-372960"/>
                <a:ext cx="7314840" cy="9144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9" name=""/>
              <p:cNvSpPr/>
              <p:nvPr/>
            </p:nvSpPr>
            <p:spPr>
              <a:xfrm>
                <a:off x="8206560" y="4957920"/>
                <a:ext cx="654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eshkopi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"/>
            <p:cNvSpPr/>
            <p:nvPr/>
          </p:nvSpPr>
          <p:spPr>
            <a:xfrm>
              <a:off x="773280" y="-3240"/>
              <a:ext cx="6749640" cy="2071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"/>
          <p:cNvSpPr/>
          <p:nvPr/>
        </p:nvSpPr>
        <p:spPr>
          <a:xfrm>
            <a:off x="410400" y="239760"/>
            <a:ext cx="1703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gure S3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1370520" y="1792080"/>
            <a:ext cx="48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urre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1588320" y="1712880"/>
            <a:ext cx="65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shkopi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6200000">
            <a:off x="1945800" y="1749600"/>
            <a:ext cx="549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rme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2261160" y="179748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2827080" y="1721160"/>
            <a:ext cx="59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lbasa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3750840" y="1725840"/>
            <a:ext cx="56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osov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4086720" y="179424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4403520" y="1768320"/>
            <a:ext cx="500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uk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4994640" y="177984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5329800" y="1776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lo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5598000" y="179892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7129800" y="1794240"/>
            <a:ext cx="52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rr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6860160" y="1776240"/>
            <a:ext cx="448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lor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30T19:53:37Z</dcterms:created>
  <dc:creator>Marco Salemi</dc:creator>
  <dc:description/>
  <dc:language>en-US</dc:language>
  <cp:lastModifiedBy>Marco Salemi</cp:lastModifiedBy>
  <dcterms:modified xsi:type="dcterms:W3CDTF">2007-09-05T05:56:58Z</dcterms:modified>
  <cp:revision>10</cp:revision>
  <dc:subject/>
  <dc:title>PowerPoint Presentation</dc:title>
</cp:coreProperties>
</file>